
<file path=[Content_Types].xml><?xml version="1.0" encoding="utf-8"?>
<Types xmlns="http://schemas.openxmlformats.org/package/2006/content-types"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3" autoAdjust="0"/>
    <p:restoredTop sz="94660"/>
  </p:normalViewPr>
  <p:slideViewPr>
    <p:cSldViewPr snapToGrid="0">
      <p:cViewPr varScale="1">
        <p:scale>
          <a:sx n="71" d="100"/>
          <a:sy n="71" d="100"/>
        </p:scale>
        <p:origin x="18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388C73-00C4-4B45-AF49-A140E7AE2818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2E8446-826D-4D47-BE5C-9846C8858F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8718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2E8446-826D-4D47-BE5C-9846C8858F00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81513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2E8446-826D-4D47-BE5C-9846C8858F00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65370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2E8446-826D-4D47-BE5C-9846C8858F00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05122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2E8446-826D-4D47-BE5C-9846C8858F00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42002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072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1807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711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4958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3798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4074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1571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9949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4674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9725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8320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102C0-D840-44A4-AB5B-7355A1081DE0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DF9A1-ACC2-4892-B2C7-8714EC8DE6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1729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>
            <a:spLocks noChangeArrowheads="1"/>
          </p:cNvSpPr>
          <p:nvPr/>
        </p:nvSpPr>
        <p:spPr bwMode="auto">
          <a:xfrm rot="10800000" flipV="1">
            <a:off x="1396218" y="-804636"/>
            <a:ext cx="6482393" cy="255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63305" tIns="31652" rIns="63305" bIns="31652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 sz="1246"/>
          </a:p>
        </p:txBody>
      </p:sp>
      <p:pic>
        <p:nvPicPr>
          <p:cNvPr id="10" name="Image 9"/>
          <p:cNvPicPr/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761" b="37018"/>
          <a:stretch/>
        </p:blipFill>
        <p:spPr bwMode="auto">
          <a:xfrm>
            <a:off x="560070" y="1963271"/>
            <a:ext cx="5786942" cy="379363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Rectangle 1"/>
          <p:cNvSpPr/>
          <p:nvPr/>
        </p:nvSpPr>
        <p:spPr>
          <a:xfrm>
            <a:off x="760400" y="6100512"/>
            <a:ext cx="599258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a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S-DA of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cal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Fisher rats distinguishing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biotic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trol treatment. 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223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/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677" y="474562"/>
            <a:ext cx="5301204" cy="619245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65932" y="6413499"/>
            <a:ext cx="61214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b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S-DA of Long-Evans rats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cal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s distinguishing probiotic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trol treatment in maternally deprived (MD+) rat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 or MD+ vs maternally non deprived MD- rats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long with significant variables selected on VIP values (see experimental section). 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4868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/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9" t="15080" r="5291" b="15278"/>
          <a:stretch/>
        </p:blipFill>
        <p:spPr bwMode="auto">
          <a:xfrm>
            <a:off x="252288" y="519033"/>
            <a:ext cx="6173912" cy="555903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Rectangle 3"/>
          <p:cNvSpPr/>
          <p:nvPr/>
        </p:nvSpPr>
        <p:spPr>
          <a:xfrm>
            <a:off x="368300" y="7017865"/>
            <a:ext cx="60579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c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S-DA of Long-Evans rats serum samples distinguishing probiotic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trol treatment in maternally deprived MD+ rats (A), or MD+ vs maternally non deprived MD- rats (B), along with significant variables selected on VIP values (see experimental section).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256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3718148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</TotalTime>
  <Words>115</Words>
  <Application>Microsoft Office PowerPoint</Application>
  <PresentationFormat>Format A4 (210 x 297 mm)</PresentationFormat>
  <Paragraphs>10</Paragraphs>
  <Slides>4</Slides>
  <Notes>4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lerie Dauge</dc:creator>
  <cp:lastModifiedBy>Valerie Dauge</cp:lastModifiedBy>
  <cp:revision>23</cp:revision>
  <dcterms:created xsi:type="dcterms:W3CDTF">2019-11-12T08:57:14Z</dcterms:created>
  <dcterms:modified xsi:type="dcterms:W3CDTF">2020-07-02T08:17:53Z</dcterms:modified>
</cp:coreProperties>
</file>